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59" r:id="rId6"/>
    <p:sldId id="270" r:id="rId7"/>
    <p:sldId id="271" r:id="rId8"/>
    <p:sldId id="272" r:id="rId9"/>
    <p:sldId id="273" r:id="rId10"/>
    <p:sldId id="261" r:id="rId11"/>
    <p:sldId id="262" r:id="rId12"/>
    <p:sldId id="268" r:id="rId13"/>
    <p:sldId id="269" r:id="rId14"/>
    <p:sldId id="263" r:id="rId15"/>
    <p:sldId id="280" r:id="rId16"/>
    <p:sldId id="266" r:id="rId17"/>
    <p:sldId id="267" r:id="rId18"/>
    <p:sldId id="264" r:id="rId19"/>
    <p:sldId id="265" r:id="rId20"/>
    <p:sldId id="289" r:id="rId21"/>
    <p:sldId id="296" r:id="rId22"/>
    <p:sldId id="290" r:id="rId23"/>
    <p:sldId id="295" r:id="rId24"/>
    <p:sldId id="291" r:id="rId25"/>
    <p:sldId id="293" r:id="rId26"/>
    <p:sldId id="292" r:id="rId27"/>
    <p:sldId id="294" r:id="rId28"/>
    <p:sldId id="279" r:id="rId29"/>
    <p:sldId id="286" r:id="rId30"/>
    <p:sldId id="284" r:id="rId31"/>
    <p:sldId id="285" r:id="rId32"/>
    <p:sldId id="309" r:id="rId33"/>
    <p:sldId id="310" r:id="rId34"/>
    <p:sldId id="311" r:id="rId35"/>
    <p:sldId id="312" r:id="rId36"/>
    <p:sldId id="282" r:id="rId37"/>
    <p:sldId id="283" r:id="rId38"/>
    <p:sldId id="297" r:id="rId39"/>
    <p:sldId id="298" r:id="rId40"/>
    <p:sldId id="299" r:id="rId41"/>
    <p:sldId id="300" r:id="rId4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2D6919A-BDA7-480C-8CE9-55CBA5D505E3}" v="499" dt="2021-02-08T23:35:35.93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29C8A78-C7B5-4C40-A839-598B9ABA11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CBBFC2DE-7DC2-4A60-984E-F77E7A6ABF9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A12C29B-0150-47FF-BC12-10C0B2C8BA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9CAC9EC-FDB8-46E0-B9FE-BB6E6AE9F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A7AAEB7-BB09-43F9-9C0D-3388181CD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845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3E4FC6F-A598-4428-9CB6-967EE5E111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BD1B8D11-C6A4-4449-8AD0-D2985159A4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43FBC2F-F762-426A-A6D7-770EADD7F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420E51C-F892-40D5-A2CF-FDDDD7E9A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2F7AA2C-40D9-40B7-A323-D079F96AD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062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D5CDED38-BA7E-4EEB-8046-2191A84BF3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553CFFF-642E-462E-B4EF-3355E325C6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B75C3A9-A719-415D-97C1-2F460763B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E7B4BC3-0990-4707-AD7E-7DBCA5CB3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4EEB90E-BBB2-4E06-9BBC-D2C1BE174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423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062DA91-543A-4156-BB56-AF291339E2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1F2D2C6-DE1C-4516-A5C1-1F63F7665E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447C9EF-60BB-43F0-BF62-7122039C12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3BFEFBA-774E-421D-8436-88984EA42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DACE5A0-EED4-45D7-A3E3-0FFFCE15C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2129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C839545-7E96-41A6-B05E-9F074D0F7E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8BC10D3-B925-40D2-A184-924D2F1E9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62EC12D-1EA3-4104-BFF7-1619AC294A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0E5831-1C62-44A7-8ADF-F1E053C36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156DDD6-0A96-4D54-A022-763CB7336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134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4FA86A5-1CE8-493B-9BA9-0CB5BB22F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3E56D5D-6EE1-4352-8F89-B31A8ABA55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86A7ECE-218F-4D52-B177-2AFA3758AB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D62D53C-6A0F-45C2-8159-18C3A75F1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4FEA7EB-F51E-451E-854B-03885BD56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654E26B-1495-4FEA-A58B-BF3CAAB95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34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4E2932-9C4C-476E-922D-2A3FD7742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7ADD8DE-6304-4C91-A335-09CFA2FFC1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DA0F9C1-3203-4CF1-9494-649D483C0A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4ED28978-B1F6-4A76-961B-C68003CDEC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07195F9E-FAB4-4594-BD12-BA49D63601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7746AB41-27B5-49AE-BF03-C3C5A124E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45EDCA2-76E6-4D15-BC9A-17EAD837F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1017CAF7-69D7-4B9B-97E3-C4165547A4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804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811767-0C45-4FF1-B84D-8D98989C7F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DFF8C41-3A75-4657-9882-861454CE7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87CC384E-DD9A-4674-B9D5-F6CDD23E6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20FC45A-C783-458B-B405-1976F1DA4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927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B7A7D74-5365-48B8-9451-8DDD91DC0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77F6F68-D02C-432B-8B2D-067CEB440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4161B25-AD87-46B4-8C4C-DEA6C24C9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789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0BB81A2-66E6-465A-AEF2-72F0900AC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9A6FB9D-CE50-49CF-99E2-61663C8C62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99BE72A-02A6-4D2C-BB0A-B2D520E8BA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94714DB-60EC-454F-B4A3-3D421313C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F07B4D6-B997-44AF-8200-83F7818B5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317DB76-FC7F-462C-A481-C936ACB627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436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072EB4-638B-4C06-A101-8D01CCDBE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723877B-CE7D-4EFD-9ABE-06FF4EC391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69AF659-2E9E-4E81-BBA8-9F26267459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C0F224D-699D-47CE-B8AB-ADFFDBBBE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2039927-A570-46CF-B666-116F345EB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9985AB3-0FEE-4479-90F2-31D2788C25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867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183391AA-96DB-4D42-87FF-5520C07543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F82E0F20-7A54-46B6-8DD7-F3DEAFF5C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AEDB3BE-8A3D-4A71-BBF8-1D8B03F6D5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5835A-E42B-419A-9B50-3E8CCEF01F89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4BCDCF5-1237-47F2-A0FC-DAA11E87A1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7B0BFF9-C172-47ED-BBDA-CF61A5C2AE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20CE1-763C-49EE-B12E-BEF45F56C8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24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C163763-78A1-4690-A68E-6D99C35269E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Images for Copy Number </a:t>
            </a:r>
            <a:r>
              <a:rPr lang="en-US" dirty="0" smtClean="0"/>
              <a:t>Review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241F000-5595-40A5-A5C7-D7C89C6F584F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V1.1 2/6/201</a:t>
            </a:r>
          </a:p>
        </p:txBody>
      </p:sp>
    </p:spTree>
    <p:extLst>
      <p:ext uri="{BB962C8B-B14F-4D97-AF65-F5344CB8AC3E}">
        <p14:creationId xmlns:p14="http://schemas.microsoft.com/office/powerpoint/2010/main" val="37862871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10BC3A7-1A8C-4FD9-9B3A-1337605FAD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IMSTOFPRO 105min DDA</a:t>
            </a:r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xmlns="" id="{73C02044-FEEF-4246-A131-E0A269D4251A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229025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3C2187-146D-4D00-8B15-A3B9856761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TIMSTOFPro</a:t>
            </a:r>
            <a:r>
              <a:rPr lang="en-US" dirty="0"/>
              <a:t> 105min DDA</a:t>
            </a:r>
          </a:p>
        </p:txBody>
      </p:sp>
      <p:pic>
        <p:nvPicPr>
          <p:cNvPr id="5122" name="Picture 2">
            <a:extLst>
              <a:ext uri="{FF2B5EF4-FFF2-40B4-BE49-F238E27FC236}">
                <a16:creationId xmlns:a16="http://schemas.microsoft.com/office/drawing/2014/main" xmlns="" id="{F9352FB4-DC6C-4161-A233-CBD51D793A35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99817144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61EEE79-FBDB-47A2-8B09-A26EA5D0ED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IMSTOF Modified </a:t>
            </a:r>
            <a:r>
              <a:rPr lang="en-US" dirty="0" err="1"/>
              <a:t>diaPASEF</a:t>
            </a:r>
            <a:r>
              <a:rPr lang="en-US" dirty="0"/>
              <a:t> 2 hour</a:t>
            </a:r>
          </a:p>
        </p:txBody>
      </p:sp>
      <p:pic>
        <p:nvPicPr>
          <p:cNvPr id="10242" name="Picture 2">
            <a:extLst>
              <a:ext uri="{FF2B5EF4-FFF2-40B4-BE49-F238E27FC236}">
                <a16:creationId xmlns:a16="http://schemas.microsoft.com/office/drawing/2014/main" xmlns="" id="{266478E1-D8B0-4298-A64A-F5B73117DB75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5814425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FF7E71-9B34-43CF-894F-5D0EDA0E31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IMSTOF Modified </a:t>
            </a:r>
            <a:r>
              <a:rPr lang="en-US" dirty="0" err="1"/>
              <a:t>diaPASEF</a:t>
            </a:r>
            <a:r>
              <a:rPr lang="en-US" dirty="0"/>
              <a:t> 2 hour</a:t>
            </a:r>
          </a:p>
        </p:txBody>
      </p:sp>
      <p:pic>
        <p:nvPicPr>
          <p:cNvPr id="11266" name="Picture 2">
            <a:extLst>
              <a:ext uri="{FF2B5EF4-FFF2-40B4-BE49-F238E27FC236}">
                <a16:creationId xmlns:a16="http://schemas.microsoft.com/office/drawing/2014/main" xmlns="" id="{21D57763-A1FA-4A85-9A4E-2960A3F00523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843362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718F336-B79B-44BF-BE54-E5DBE441F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ite 15cm column OT-OT 120min</a:t>
            </a:r>
          </a:p>
        </p:txBody>
      </p:sp>
      <p:pic>
        <p:nvPicPr>
          <p:cNvPr id="16386" name="Picture 2">
            <a:extLst>
              <a:ext uri="{FF2B5EF4-FFF2-40B4-BE49-F238E27FC236}">
                <a16:creationId xmlns:a16="http://schemas.microsoft.com/office/drawing/2014/main" xmlns="" id="{DEE948CA-9954-404E-8F6D-BF9E68B04733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343954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E8ACA98-9FA8-4615-A686-72DBC124CC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17410" name="Picture 2">
            <a:extLst>
              <a:ext uri="{FF2B5EF4-FFF2-40B4-BE49-F238E27FC236}">
                <a16:creationId xmlns:a16="http://schemas.microsoft.com/office/drawing/2014/main" xmlns="" id="{DADD6E86-9333-4F1E-BF15-0596A2922A5E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644047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1DDCCD1-F8ED-4427-8A02-648A395B0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ite 50cm 210min OT-OT</a:t>
            </a:r>
          </a:p>
        </p:txBody>
      </p:sp>
      <p:pic>
        <p:nvPicPr>
          <p:cNvPr id="8194" name="Picture 2">
            <a:extLst>
              <a:ext uri="{FF2B5EF4-FFF2-40B4-BE49-F238E27FC236}">
                <a16:creationId xmlns:a16="http://schemas.microsoft.com/office/drawing/2014/main" xmlns="" id="{8DB7D243-DE60-43F7-BA55-D51FE228D439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417964639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D478877-F434-47E3-983A-4BA2FDA07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9218" name="Picture 2">
            <a:extLst>
              <a:ext uri="{FF2B5EF4-FFF2-40B4-BE49-F238E27FC236}">
                <a16:creationId xmlns:a16="http://schemas.microsoft.com/office/drawing/2014/main" xmlns="" id="{BC5D3922-FAA5-4F6C-A115-F66F0995FAF3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4306584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D975495-F6F0-45D5-AB20-294CB416F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lite 75cm 9 hours OTOT</a:t>
            </a:r>
          </a:p>
        </p:txBody>
      </p:sp>
      <p:pic>
        <p:nvPicPr>
          <p:cNvPr id="6146" name="Picture 2">
            <a:extLst>
              <a:ext uri="{FF2B5EF4-FFF2-40B4-BE49-F238E27FC236}">
                <a16:creationId xmlns:a16="http://schemas.microsoft.com/office/drawing/2014/main" xmlns="" id="{6C46371F-3BE1-4FAF-A6D1-7BC3EF45FBEE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3808662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8F1C570-F5D8-4B8F-8387-0133C96075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7170" name="Picture 2">
            <a:extLst>
              <a:ext uri="{FF2B5EF4-FFF2-40B4-BE49-F238E27FC236}">
                <a16:creationId xmlns:a16="http://schemas.microsoft.com/office/drawing/2014/main" xmlns="" id="{C795FAE6-10C5-4505-A7B7-CA870A10DFDF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14889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15ACF06-5852-4908-B4AD-8F7998DA1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OMASCAN 1300 </a:t>
            </a:r>
          </a:p>
        </p:txBody>
      </p:sp>
      <p:pic>
        <p:nvPicPr>
          <p:cNvPr id="5" name="Content Placeholder 4" descr="Chart, histogram&#10;&#10;Description automatically generated">
            <a:extLst>
              <a:ext uri="{FF2B5EF4-FFF2-40B4-BE49-F238E27FC236}">
                <a16:creationId xmlns:a16="http://schemas.microsoft.com/office/drawing/2014/main" xmlns="" id="{09A2E58E-0647-4804-AEAB-AD02AAD9A05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1427" y="1825625"/>
            <a:ext cx="10369146" cy="4351338"/>
          </a:xfrm>
        </p:spPr>
      </p:pic>
    </p:spTree>
    <p:extLst>
      <p:ext uri="{BB962C8B-B14F-4D97-AF65-F5344CB8AC3E}">
        <p14:creationId xmlns:p14="http://schemas.microsoft.com/office/powerpoint/2010/main" val="91329621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633B52-0C5A-4A62-8D75-66BFA8674C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60min HCD-IT</a:t>
            </a:r>
          </a:p>
        </p:txBody>
      </p:sp>
      <p:pic>
        <p:nvPicPr>
          <p:cNvPr id="32770" name="Picture 2">
            <a:extLst>
              <a:ext uri="{FF2B5EF4-FFF2-40B4-BE49-F238E27FC236}">
                <a16:creationId xmlns:a16="http://schemas.microsoft.com/office/drawing/2014/main" xmlns="" id="{EC0B380D-18C4-4AED-9931-B837FAF6BD65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1073312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55D3EDB-7012-428D-B3F4-4ADA40098F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60min HCD-IT</a:t>
            </a:r>
          </a:p>
        </p:txBody>
      </p:sp>
      <p:pic>
        <p:nvPicPr>
          <p:cNvPr id="33794" name="Picture 2">
            <a:extLst>
              <a:ext uri="{FF2B5EF4-FFF2-40B4-BE49-F238E27FC236}">
                <a16:creationId xmlns:a16="http://schemas.microsoft.com/office/drawing/2014/main" xmlns="" id="{A799D254-D116-44ED-8DB1-A0873DD90364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6469155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42F64E8-0276-4E0B-A6CC-9CDDAB629A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90 min HCD-IT</a:t>
            </a:r>
          </a:p>
        </p:txBody>
      </p:sp>
      <p:pic>
        <p:nvPicPr>
          <p:cNvPr id="30722" name="Picture 2">
            <a:extLst>
              <a:ext uri="{FF2B5EF4-FFF2-40B4-BE49-F238E27FC236}">
                <a16:creationId xmlns:a16="http://schemas.microsoft.com/office/drawing/2014/main" xmlns="" id="{8A2085A6-A7C3-47B2-81F3-AD08880F3760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2099657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6AF640F-1170-4B0B-940F-617DD17F86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90 min</a:t>
            </a:r>
          </a:p>
        </p:txBody>
      </p:sp>
      <p:pic>
        <p:nvPicPr>
          <p:cNvPr id="31746" name="Picture 2">
            <a:extLst>
              <a:ext uri="{FF2B5EF4-FFF2-40B4-BE49-F238E27FC236}">
                <a16:creationId xmlns:a16="http://schemas.microsoft.com/office/drawing/2014/main" xmlns="" id="{B34A46EC-B24B-4AEA-BA7C-81B6EFFFD716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9172535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5DD0284-D437-4B8C-98CE-34221DD10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120min HCD-IT</a:t>
            </a:r>
          </a:p>
        </p:txBody>
      </p:sp>
      <p:pic>
        <p:nvPicPr>
          <p:cNvPr id="26626" name="Picture 2">
            <a:extLst>
              <a:ext uri="{FF2B5EF4-FFF2-40B4-BE49-F238E27FC236}">
                <a16:creationId xmlns:a16="http://schemas.microsoft.com/office/drawing/2014/main" xmlns="" id="{3EED8EAA-E348-4D97-A028-9BB46E5BF1AE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1192988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50986AB-7C8E-4077-B06B-B19B0AC019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120</a:t>
            </a:r>
          </a:p>
        </p:txBody>
      </p:sp>
      <p:pic>
        <p:nvPicPr>
          <p:cNvPr id="27650" name="Picture 2">
            <a:extLst>
              <a:ext uri="{FF2B5EF4-FFF2-40B4-BE49-F238E27FC236}">
                <a16:creationId xmlns:a16="http://schemas.microsoft.com/office/drawing/2014/main" xmlns="" id="{CB9BBD13-83CB-4306-B89E-628228067DBF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338286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CF416C9-6224-45AB-A4B1-D70F163194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240min 50cm column HCD-IT </a:t>
            </a:r>
          </a:p>
        </p:txBody>
      </p:sp>
      <p:pic>
        <p:nvPicPr>
          <p:cNvPr id="28676" name="Picture 4">
            <a:extLst>
              <a:ext uri="{FF2B5EF4-FFF2-40B4-BE49-F238E27FC236}">
                <a16:creationId xmlns:a16="http://schemas.microsoft.com/office/drawing/2014/main" xmlns="" id="{6A444872-C874-476E-83C2-71CF641DC8F9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9856658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272C6B3-DD48-4EF9-92CA-94954B2FA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umos 240min</a:t>
            </a:r>
          </a:p>
        </p:txBody>
      </p:sp>
      <p:pic>
        <p:nvPicPr>
          <p:cNvPr id="29698" name="Picture 2">
            <a:extLst>
              <a:ext uri="{FF2B5EF4-FFF2-40B4-BE49-F238E27FC236}">
                <a16:creationId xmlns:a16="http://schemas.microsoft.com/office/drawing/2014/main" xmlns="" id="{1B58F75C-CFEA-4882-8941-4A7E6C5B9004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2888149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54B46E8-A37D-4906-8192-ADDEB4F49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E Classic 2 hours 200ng</a:t>
            </a:r>
          </a:p>
        </p:txBody>
      </p:sp>
      <p:pic>
        <p:nvPicPr>
          <p:cNvPr id="22530" name="Picture 2">
            <a:extLst>
              <a:ext uri="{FF2B5EF4-FFF2-40B4-BE49-F238E27FC236}">
                <a16:creationId xmlns:a16="http://schemas.microsoft.com/office/drawing/2014/main" xmlns="" id="{DDECCF23-73F1-43D7-9D50-1B5290F4C4B6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6525611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95061E6-E736-4D7A-95B4-7956D44970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E Classic 2 hours 200ng</a:t>
            </a:r>
          </a:p>
        </p:txBody>
      </p:sp>
      <p:pic>
        <p:nvPicPr>
          <p:cNvPr id="23554" name="Picture 2">
            <a:extLst>
              <a:ext uri="{FF2B5EF4-FFF2-40B4-BE49-F238E27FC236}">
                <a16:creationId xmlns:a16="http://schemas.microsoft.com/office/drawing/2014/main" xmlns="" id="{7A7F3498-BD27-4B23-9C5E-C2DAA4BCDE2B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77537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3ADF6FD-7CD3-41E4-9953-76DCD8D927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xmlns="" id="{900E1B59-EFFD-4110-9C1C-0402041FA70B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1112263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2B0118B-041E-42FD-BD19-97E5C1B8EF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QE HF 200ng 2 hours</a:t>
            </a:r>
          </a:p>
        </p:txBody>
      </p:sp>
      <p:pic>
        <p:nvPicPr>
          <p:cNvPr id="24578" name="Picture 2">
            <a:extLst>
              <a:ext uri="{FF2B5EF4-FFF2-40B4-BE49-F238E27FC236}">
                <a16:creationId xmlns:a16="http://schemas.microsoft.com/office/drawing/2014/main" xmlns="" id="{F32F278F-2B93-4D4F-ABB2-A412A7919465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20156448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38FD394-F4A1-4577-B4BC-C30A27E0B8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F 2 hours</a:t>
            </a:r>
          </a:p>
        </p:txBody>
      </p:sp>
      <p:pic>
        <p:nvPicPr>
          <p:cNvPr id="25602" name="Picture 2">
            <a:extLst>
              <a:ext uri="{FF2B5EF4-FFF2-40B4-BE49-F238E27FC236}">
                <a16:creationId xmlns:a16="http://schemas.microsoft.com/office/drawing/2014/main" xmlns="" id="{41C87F9D-5F0B-4AA8-8DA7-191D75BE8864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2585777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A79559-BDEC-4769-A8BA-410B5097A4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oxCar 60min</a:t>
            </a:r>
          </a:p>
        </p:txBody>
      </p:sp>
      <p:pic>
        <p:nvPicPr>
          <p:cNvPr id="38914" name="Picture 2">
            <a:extLst>
              <a:ext uri="{FF2B5EF4-FFF2-40B4-BE49-F238E27FC236}">
                <a16:creationId xmlns:a16="http://schemas.microsoft.com/office/drawing/2014/main" xmlns="" id="{DF0F1127-B210-439A-863D-8467F3DA7BC2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3030" y="1825625"/>
            <a:ext cx="8505940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86925379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723D4F-2BBB-429A-982B-9CC08008E4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oxCar 60min</a:t>
            </a:r>
          </a:p>
        </p:txBody>
      </p:sp>
      <p:pic>
        <p:nvPicPr>
          <p:cNvPr id="45058" name="Picture 2">
            <a:extLst>
              <a:ext uri="{FF2B5EF4-FFF2-40B4-BE49-F238E27FC236}">
                <a16:creationId xmlns:a16="http://schemas.microsoft.com/office/drawing/2014/main" xmlns="" id="{382D6975-37E9-4DD3-B5CF-40B27C83C34B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3030" y="1825625"/>
            <a:ext cx="8505940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74031509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B53AC5-36DC-442A-99B4-9DD0DBB83D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oxCar 60min identified by MS2</a:t>
            </a:r>
          </a:p>
        </p:txBody>
      </p:sp>
      <p:pic>
        <p:nvPicPr>
          <p:cNvPr id="46082" name="Picture 2">
            <a:extLst>
              <a:ext uri="{FF2B5EF4-FFF2-40B4-BE49-F238E27FC236}">
                <a16:creationId xmlns:a16="http://schemas.microsoft.com/office/drawing/2014/main" xmlns="" id="{AA91E979-85E6-4C93-A081-28542AA1465C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3030" y="1825625"/>
            <a:ext cx="8505940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29560627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A05EBE5-FD76-4DFC-A577-20B9494521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oxCar 60min MS2 only</a:t>
            </a:r>
          </a:p>
        </p:txBody>
      </p:sp>
      <p:pic>
        <p:nvPicPr>
          <p:cNvPr id="47106" name="Picture 2">
            <a:extLst>
              <a:ext uri="{FF2B5EF4-FFF2-40B4-BE49-F238E27FC236}">
                <a16:creationId xmlns:a16="http://schemas.microsoft.com/office/drawing/2014/main" xmlns="" id="{F31A1278-5111-4F1D-B36F-936ADAB15A9D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43030" y="1825625"/>
            <a:ext cx="8505940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98180217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C56467-00D6-4F4E-B1BB-CF64743BC7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ploris 60min 120k/7.5k/200ng</a:t>
            </a:r>
          </a:p>
        </p:txBody>
      </p:sp>
      <p:pic>
        <p:nvPicPr>
          <p:cNvPr id="20482" name="Picture 2">
            <a:extLst>
              <a:ext uri="{FF2B5EF4-FFF2-40B4-BE49-F238E27FC236}">
                <a16:creationId xmlns:a16="http://schemas.microsoft.com/office/drawing/2014/main" xmlns="" id="{143E4770-7D21-43E7-804F-468BC4C07B31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24629060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0D5FA85-8801-4B63-B30E-1FCE555DD2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ploris 120k/15k 60min</a:t>
            </a:r>
          </a:p>
        </p:txBody>
      </p:sp>
      <p:pic>
        <p:nvPicPr>
          <p:cNvPr id="21506" name="Picture 2">
            <a:extLst>
              <a:ext uri="{FF2B5EF4-FFF2-40B4-BE49-F238E27FC236}">
                <a16:creationId xmlns:a16="http://schemas.microsoft.com/office/drawing/2014/main" xmlns="" id="{0E22751F-CF99-40BD-9FBD-54ABAC3E6996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01891450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263E401-65B7-49C5-9658-A648108F5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MF Fusion 1 IT 120min</a:t>
            </a:r>
          </a:p>
        </p:txBody>
      </p:sp>
      <p:pic>
        <p:nvPicPr>
          <p:cNvPr id="34818" name="Picture 2">
            <a:extLst>
              <a:ext uri="{FF2B5EF4-FFF2-40B4-BE49-F238E27FC236}">
                <a16:creationId xmlns:a16="http://schemas.microsoft.com/office/drawing/2014/main" xmlns="" id="{C816E4E9-6FE8-4E4B-8269-2B70F809B0BB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40598526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C672C30-3D16-45C1-988B-5AA2FB9BB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MF Fusion 1</a:t>
            </a:r>
          </a:p>
        </p:txBody>
      </p:sp>
      <p:pic>
        <p:nvPicPr>
          <p:cNvPr id="35842" name="Picture 2">
            <a:extLst>
              <a:ext uri="{FF2B5EF4-FFF2-40B4-BE49-F238E27FC236}">
                <a16:creationId xmlns:a16="http://schemas.microsoft.com/office/drawing/2014/main" xmlns="" id="{53AF3AFA-6B63-477F-AB48-BEB3C91E4573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000906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4FF4609-CB52-416C-9B2F-FB2A9CC02F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AIMS70 Exploris 21 min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xmlns="" id="{92E9A7DB-2FDE-4EBE-BE21-1894733D68E3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26393202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21F0AC9-15BC-4CD9-A682-51ABB4AF2B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niversal Fusion 1</a:t>
            </a:r>
          </a:p>
        </p:txBody>
      </p:sp>
      <p:pic>
        <p:nvPicPr>
          <p:cNvPr id="36866" name="Picture 2">
            <a:extLst>
              <a:ext uri="{FF2B5EF4-FFF2-40B4-BE49-F238E27FC236}">
                <a16:creationId xmlns:a16="http://schemas.microsoft.com/office/drawing/2014/main" xmlns="" id="{CBC7747C-FC74-4A64-A594-11730588D507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08562940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3038F15-E6F8-4AD6-8E6B-64288068F1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usion IT universal</a:t>
            </a:r>
          </a:p>
        </p:txBody>
      </p:sp>
      <p:pic>
        <p:nvPicPr>
          <p:cNvPr id="37890" name="Picture 2">
            <a:extLst>
              <a:ext uri="{FF2B5EF4-FFF2-40B4-BE49-F238E27FC236}">
                <a16:creationId xmlns:a16="http://schemas.microsoft.com/office/drawing/2014/main" xmlns="" id="{9BAAC64E-92A8-4B60-97BE-8592DC1C0B28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00314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499CFE9-8B33-4053-956E-6A57F4EB9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xmlns="" id="{A8970437-3F58-4DFB-BD20-F4912E39E536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306586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F21FA38-F374-4BF8-AD61-C8CAF64150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ZipChip QE HF 12 minutes</a:t>
            </a:r>
          </a:p>
        </p:txBody>
      </p:sp>
      <p:pic>
        <p:nvPicPr>
          <p:cNvPr id="12290" name="Picture 2">
            <a:extLst>
              <a:ext uri="{FF2B5EF4-FFF2-40B4-BE49-F238E27FC236}">
                <a16:creationId xmlns:a16="http://schemas.microsoft.com/office/drawing/2014/main" xmlns="" id="{F890210B-0779-4952-A0BC-B90DA6C05DB8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423987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0A17307-DE82-40EC-8EAE-BF6625DAFF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ZipChip QE HF 12 min</a:t>
            </a:r>
          </a:p>
        </p:txBody>
      </p:sp>
      <p:pic>
        <p:nvPicPr>
          <p:cNvPr id="13314" name="Picture 2">
            <a:extLst>
              <a:ext uri="{FF2B5EF4-FFF2-40B4-BE49-F238E27FC236}">
                <a16:creationId xmlns:a16="http://schemas.microsoft.com/office/drawing/2014/main" xmlns="" id="{EAE670C8-D403-47EC-BFE6-687CD164BE49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1824669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5EA95BE-61C7-4B3F-9616-B1ACD2A5EA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F-X DIA 21min EVOSEP 30k-15k</a:t>
            </a:r>
          </a:p>
        </p:txBody>
      </p:sp>
      <p:pic>
        <p:nvPicPr>
          <p:cNvPr id="14338" name="Picture 2">
            <a:extLst>
              <a:ext uri="{FF2B5EF4-FFF2-40B4-BE49-F238E27FC236}">
                <a16:creationId xmlns:a16="http://schemas.microsoft.com/office/drawing/2014/main" xmlns="" id="{9FE8AB44-E57E-4F1F-9697-95A6A3CEA9F4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172007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40A4860-34EF-435C-8F79-0848B42F70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F-X DIA 21min EVOSEP 30k-15k</a:t>
            </a:r>
          </a:p>
        </p:txBody>
      </p:sp>
      <p:pic>
        <p:nvPicPr>
          <p:cNvPr id="15362" name="Picture 2">
            <a:extLst>
              <a:ext uri="{FF2B5EF4-FFF2-40B4-BE49-F238E27FC236}">
                <a16:creationId xmlns:a16="http://schemas.microsoft.com/office/drawing/2014/main" xmlns="" id="{8F981B35-71B5-4950-BB9B-F1ED4888EB82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1427" y="1825625"/>
            <a:ext cx="10369146" cy="4351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119185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96</TotalTime>
  <Words>140</Words>
  <Application>Microsoft Office PowerPoint</Application>
  <PresentationFormat>Widescreen</PresentationFormat>
  <Paragraphs>37</Paragraphs>
  <Slides>4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1</vt:i4>
      </vt:variant>
    </vt:vector>
  </HeadingPairs>
  <TitlesOfParts>
    <vt:vector size="45" baseType="lpstr">
      <vt:lpstr>Arial</vt:lpstr>
      <vt:lpstr>Calibri</vt:lpstr>
      <vt:lpstr>Calibri Light</vt:lpstr>
      <vt:lpstr>Office Theme</vt:lpstr>
      <vt:lpstr>Supplemental Images for Copy Number Review</vt:lpstr>
      <vt:lpstr>SOMASCAN 1300 </vt:lpstr>
      <vt:lpstr>PowerPoint Presentation</vt:lpstr>
      <vt:lpstr>FAIMS70 Exploris 21 min</vt:lpstr>
      <vt:lpstr>PowerPoint Presentation</vt:lpstr>
      <vt:lpstr>ZipChip QE HF 12 minutes</vt:lpstr>
      <vt:lpstr>ZipChip QE HF 12 min</vt:lpstr>
      <vt:lpstr>HF-X DIA 21min EVOSEP 30k-15k</vt:lpstr>
      <vt:lpstr>HF-X DIA 21min EVOSEP 30k-15k</vt:lpstr>
      <vt:lpstr>TIMSTOFPRO 105min DDA</vt:lpstr>
      <vt:lpstr>TIMSTOFPro 105min DDA</vt:lpstr>
      <vt:lpstr>TIMSTOF Modified diaPASEF 2 hour</vt:lpstr>
      <vt:lpstr>TIMSTOF Modified diaPASEF 2 hour</vt:lpstr>
      <vt:lpstr>Elite 15cm column OT-OT 120min</vt:lpstr>
      <vt:lpstr>PowerPoint Presentation</vt:lpstr>
      <vt:lpstr>Elite 50cm 210min OT-OT</vt:lpstr>
      <vt:lpstr>PowerPoint Presentation</vt:lpstr>
      <vt:lpstr>Elite 75cm 9 hours OTOT</vt:lpstr>
      <vt:lpstr>PowerPoint Presentation</vt:lpstr>
      <vt:lpstr>Lumos 60min HCD-IT</vt:lpstr>
      <vt:lpstr>Lumos 60min HCD-IT</vt:lpstr>
      <vt:lpstr>Lumos 90 min HCD-IT</vt:lpstr>
      <vt:lpstr>Lumos 90 min</vt:lpstr>
      <vt:lpstr>Lumos 120min HCD-IT</vt:lpstr>
      <vt:lpstr>Lumos 120</vt:lpstr>
      <vt:lpstr>Lumos 240min 50cm column HCD-IT </vt:lpstr>
      <vt:lpstr>Lumos 240min</vt:lpstr>
      <vt:lpstr>QE Classic 2 hours 200ng</vt:lpstr>
      <vt:lpstr>QE Classic 2 hours 200ng</vt:lpstr>
      <vt:lpstr>QE HF 200ng 2 hours</vt:lpstr>
      <vt:lpstr>HF 2 hours</vt:lpstr>
      <vt:lpstr>BoxCar 60min</vt:lpstr>
      <vt:lpstr>BoxCar 60min</vt:lpstr>
      <vt:lpstr>BoxCar 60min identified by MS2</vt:lpstr>
      <vt:lpstr>BoxCar 60min MS2 only</vt:lpstr>
      <vt:lpstr>Exploris 60min 120k/7.5k/200ng</vt:lpstr>
      <vt:lpstr>Exploris 120k/15k 60min</vt:lpstr>
      <vt:lpstr>BAMF Fusion 1 IT 120min</vt:lpstr>
      <vt:lpstr>BAMF Fusion 1</vt:lpstr>
      <vt:lpstr>Universal Fusion 1</vt:lpstr>
      <vt:lpstr>Fusion IT universal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Images for Copy Number Reviewe</dc:title>
  <dc:creator>ben orsburn</dc:creator>
  <cp:lastModifiedBy>MDPI</cp:lastModifiedBy>
  <cp:revision>24</cp:revision>
  <dcterms:created xsi:type="dcterms:W3CDTF">2021-02-06T16:08:19Z</dcterms:created>
  <dcterms:modified xsi:type="dcterms:W3CDTF">2021-07-20T09:05:58Z</dcterms:modified>
</cp:coreProperties>
</file>